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6858000" type="screen4x3"/>
  <p:notesSz cx="6864350" cy="999648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777" autoAdjust="0"/>
    <p:restoredTop sz="99264" autoAdjust="0"/>
  </p:normalViewPr>
  <p:slideViewPr>
    <p:cSldViewPr>
      <p:cViewPr varScale="1">
        <p:scale>
          <a:sx n="98" d="100"/>
          <a:sy n="98" d="100"/>
        </p:scale>
        <p:origin x="-821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chirurgie\data\HP-CH\AG%20Beier-Boos\Gro&#223;tier%20Schaf\Annika%20Weigand\Lipotransfer_Annika\Ergebnisse\PCR\Publikation\Ergebnisse%20f++r%20Publikation%20SLA%20FST%20KB%20MBE%20PS%20EJ_14_2015_4_4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PS'!$X$179</c:f>
              <c:strCache>
                <c:ptCount val="1"/>
                <c:pt idx="0">
                  <c:v>MES IF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PS'!$Y$178:$Z$178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PS'!$Y$179:$Z$179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PS'!$X$180</c:f>
              <c:strCache>
                <c:ptCount val="1"/>
                <c:pt idx="0">
                  <c:v>HMEC IFDUC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Y$184:$Z$184</c:f>
                <c:numCache>
                  <c:formatCode>General</c:formatCode>
                  <c:ptCount val="2"/>
                  <c:pt idx="0">
                    <c:v>6.5327171527043339E-3</c:v>
                  </c:pt>
                  <c:pt idx="1">
                    <c:v>2.1879728952364137E-2</c:v>
                  </c:pt>
                </c:numCache>
              </c:numRef>
            </c:plus>
            <c:minus>
              <c:numRef>
                <c:f>'ADSC PS'!$Y$184:$Z$184</c:f>
                <c:numCache>
                  <c:formatCode>General</c:formatCode>
                  <c:ptCount val="2"/>
                  <c:pt idx="0">
                    <c:v>6.5327171527043339E-3</c:v>
                  </c:pt>
                  <c:pt idx="1">
                    <c:v>2.1879728952364137E-2</c:v>
                  </c:pt>
                </c:numCache>
              </c:numRef>
            </c:minus>
          </c:errBars>
          <c:cat>
            <c:strRef>
              <c:f>'ADSC PS'!$Y$178:$Z$178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PS'!$Y$180:$Z$180</c:f>
              <c:numCache>
                <c:formatCode>General</c:formatCode>
                <c:ptCount val="2"/>
                <c:pt idx="0">
                  <c:v>6.6269233607197262E-2</c:v>
                </c:pt>
                <c:pt idx="1">
                  <c:v>8.0655263913937791E-2</c:v>
                </c:pt>
              </c:numCache>
            </c:numRef>
          </c:val>
        </c:ser>
        <c:ser>
          <c:idx val="2"/>
          <c:order val="2"/>
          <c:tx>
            <c:strRef>
              <c:f>'ADSC PS'!$X$181</c:f>
              <c:strCache>
                <c:ptCount val="1"/>
                <c:pt idx="0">
                  <c:v>ADSC IF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Y$185:$Z$185</c:f>
                <c:numCache>
                  <c:formatCode>General</c:formatCode>
                  <c:ptCount val="2"/>
                  <c:pt idx="0">
                    <c:v>1.9646993065207743</c:v>
                  </c:pt>
                  <c:pt idx="1">
                    <c:v>0.33146251448274028</c:v>
                  </c:pt>
                </c:numCache>
              </c:numRef>
            </c:plus>
            <c:minus>
              <c:numRef>
                <c:f>'ADSC PS'!$Y$185:$Z$185</c:f>
                <c:numCache>
                  <c:formatCode>General</c:formatCode>
                  <c:ptCount val="2"/>
                  <c:pt idx="0">
                    <c:v>1.9646993065207743</c:v>
                  </c:pt>
                  <c:pt idx="1">
                    <c:v>0.33146251448274028</c:v>
                  </c:pt>
                </c:numCache>
              </c:numRef>
            </c:minus>
          </c:errBars>
          <c:cat>
            <c:strRef>
              <c:f>'ADSC PS'!$Y$178:$Z$178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PS'!$Y$181:$Z$181</c:f>
              <c:numCache>
                <c:formatCode>General</c:formatCode>
                <c:ptCount val="2"/>
                <c:pt idx="0">
                  <c:v>6.9933804001159361</c:v>
                </c:pt>
                <c:pt idx="1">
                  <c:v>1.25189954763738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335104"/>
        <c:axId val="176345088"/>
      </c:barChart>
      <c:catAx>
        <c:axId val="176335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6345088"/>
        <c:crosses val="autoZero"/>
        <c:auto val="1"/>
        <c:lblAlgn val="ctr"/>
        <c:lblOffset val="100"/>
        <c:noMultiLvlLbl val="0"/>
      </c:catAx>
      <c:valAx>
        <c:axId val="1763450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63351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SLA'!$P$177</c:f>
              <c:strCache>
                <c:ptCount val="1"/>
                <c:pt idx="0">
                  <c:v>MES NORMA2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SLA'!$Q$176:$U$176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SLA'!$Q$177:$U$177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SLA'!$P$178</c:f>
              <c:strCache>
                <c:ptCount val="1"/>
                <c:pt idx="0">
                  <c:v>HMEC NORMA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Q$182:$U$182</c:f>
                <c:numCache>
                  <c:formatCode>General</c:formatCode>
                  <c:ptCount val="5"/>
                  <c:pt idx="0">
                    <c:v>4.3010290467203761E-2</c:v>
                  </c:pt>
                  <c:pt idx="1">
                    <c:v>0.17504784545106719</c:v>
                  </c:pt>
                  <c:pt idx="2">
                    <c:v>2.8959356745447307E-2</c:v>
                  </c:pt>
                  <c:pt idx="3">
                    <c:v>0.11225215727756617</c:v>
                  </c:pt>
                  <c:pt idx="4">
                    <c:v>3.4616311470742687E-3</c:v>
                  </c:pt>
                </c:numCache>
              </c:numRef>
            </c:plus>
            <c:minus>
              <c:numRef>
                <c:f>'ADSC SLA'!$Q$182:$U$182</c:f>
                <c:numCache>
                  <c:formatCode>General</c:formatCode>
                  <c:ptCount val="5"/>
                  <c:pt idx="0">
                    <c:v>4.3010290467203761E-2</c:v>
                  </c:pt>
                  <c:pt idx="1">
                    <c:v>0.17504784545106719</c:v>
                  </c:pt>
                  <c:pt idx="2">
                    <c:v>2.8959356745447307E-2</c:v>
                  </c:pt>
                  <c:pt idx="3">
                    <c:v>0.11225215727756617</c:v>
                  </c:pt>
                  <c:pt idx="4">
                    <c:v>3.4616311470742687E-3</c:v>
                  </c:pt>
                </c:numCache>
              </c:numRef>
            </c:minus>
          </c:errBars>
          <c:cat>
            <c:strRef>
              <c:f>'ADSC SLA'!$Q$176:$U$176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SLA'!$Q$178:$U$178</c:f>
              <c:numCache>
                <c:formatCode>General</c:formatCode>
                <c:ptCount val="5"/>
                <c:pt idx="0">
                  <c:v>0.19172631960531614</c:v>
                </c:pt>
                <c:pt idx="1">
                  <c:v>0.76598224338860266</c:v>
                </c:pt>
                <c:pt idx="2">
                  <c:v>0.51103050650520998</c:v>
                </c:pt>
                <c:pt idx="3">
                  <c:v>0.53618904007364465</c:v>
                </c:pt>
                <c:pt idx="4">
                  <c:v>2.0936357960761213E-2</c:v>
                </c:pt>
              </c:numCache>
            </c:numRef>
          </c:val>
        </c:ser>
        <c:ser>
          <c:idx val="2"/>
          <c:order val="2"/>
          <c:tx>
            <c:strRef>
              <c:f>'ADSC SLA'!$P$179</c:f>
              <c:strCache>
                <c:ptCount val="1"/>
                <c:pt idx="0">
                  <c:v>ADSC NORMA2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Q$183:$U$183</c:f>
                <c:numCache>
                  <c:formatCode>General</c:formatCode>
                  <c:ptCount val="5"/>
                  <c:pt idx="0">
                    <c:v>2.144293321061634</c:v>
                  </c:pt>
                  <c:pt idx="1">
                    <c:v>4.1411982156747763E-4</c:v>
                  </c:pt>
                  <c:pt idx="2">
                    <c:v>4.0865464242490184</c:v>
                  </c:pt>
                  <c:pt idx="3">
                    <c:v>0.36642089230848934</c:v>
                  </c:pt>
                  <c:pt idx="4">
                    <c:v>1.139913881754949</c:v>
                  </c:pt>
                </c:numCache>
              </c:numRef>
            </c:plus>
            <c:minus>
              <c:numRef>
                <c:f>'ADSC SLA'!$Q$183:$U$183</c:f>
                <c:numCache>
                  <c:formatCode>General</c:formatCode>
                  <c:ptCount val="5"/>
                  <c:pt idx="0">
                    <c:v>2.144293321061634</c:v>
                  </c:pt>
                  <c:pt idx="1">
                    <c:v>4.1411982156747763E-4</c:v>
                  </c:pt>
                  <c:pt idx="2">
                    <c:v>4.0865464242490184</c:v>
                  </c:pt>
                  <c:pt idx="3">
                    <c:v>0.36642089230848934</c:v>
                  </c:pt>
                  <c:pt idx="4">
                    <c:v>1.139913881754949</c:v>
                  </c:pt>
                </c:numCache>
              </c:numRef>
            </c:minus>
          </c:errBars>
          <c:cat>
            <c:strRef>
              <c:f>'ADSC SLA'!$Q$176:$U$176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SLA'!$Q$179:$U$179</c:f>
              <c:numCache>
                <c:formatCode>General</c:formatCode>
                <c:ptCount val="5"/>
                <c:pt idx="0">
                  <c:v>7.8130101361107656</c:v>
                </c:pt>
                <c:pt idx="1">
                  <c:v>3.2988909466782289E-3</c:v>
                </c:pt>
                <c:pt idx="2">
                  <c:v>16.710332542431534</c:v>
                </c:pt>
                <c:pt idx="3">
                  <c:v>1.022251339782368</c:v>
                </c:pt>
                <c:pt idx="4">
                  <c:v>1.84962041394673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044736"/>
        <c:axId val="179046272"/>
      </c:barChart>
      <c:catAx>
        <c:axId val="179044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9046272"/>
        <c:crosses val="autoZero"/>
        <c:auto val="1"/>
        <c:lblAlgn val="ctr"/>
        <c:lblOffset val="100"/>
        <c:noMultiLvlLbl val="0"/>
      </c:catAx>
      <c:valAx>
        <c:axId val="1790462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90447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FST'!$X$176</c:f>
              <c:strCache>
                <c:ptCount val="1"/>
                <c:pt idx="0">
                  <c:v>MES NORMA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FST'!$Y$175:$Z$175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FST'!$Y$176:$Z$17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FST'!$X$177</c:f>
              <c:strCache>
                <c:ptCount val="1"/>
                <c:pt idx="0">
                  <c:v>HMEC NORMA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Y$182:$Z$182</c:f>
                <c:numCache>
                  <c:formatCode>General</c:formatCode>
                  <c:ptCount val="2"/>
                  <c:pt idx="0">
                    <c:v>4.7577894983220972E-2</c:v>
                  </c:pt>
                  <c:pt idx="1">
                    <c:v>0.27006957480657084</c:v>
                  </c:pt>
                </c:numCache>
              </c:numRef>
            </c:plus>
            <c:minus>
              <c:numRef>
                <c:f>'ADSC FST'!$Y$182:$Z$182</c:f>
                <c:numCache>
                  <c:formatCode>General</c:formatCode>
                  <c:ptCount val="2"/>
                  <c:pt idx="0">
                    <c:v>4.7577894983220972E-2</c:v>
                  </c:pt>
                  <c:pt idx="1">
                    <c:v>0.27006957480657084</c:v>
                  </c:pt>
                </c:numCache>
              </c:numRef>
            </c:minus>
          </c:errBars>
          <c:cat>
            <c:strRef>
              <c:f>'ADSC FST'!$Y$175:$Z$175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FST'!$Y$177:$Z$177</c:f>
              <c:numCache>
                <c:formatCode>General</c:formatCode>
                <c:ptCount val="2"/>
                <c:pt idx="0">
                  <c:v>0.2012007413634965</c:v>
                </c:pt>
                <c:pt idx="1">
                  <c:v>2.4692433633599249</c:v>
                </c:pt>
              </c:numCache>
            </c:numRef>
          </c:val>
        </c:ser>
        <c:ser>
          <c:idx val="2"/>
          <c:order val="2"/>
          <c:tx>
            <c:strRef>
              <c:f>'ADSC FST'!$X$178</c:f>
              <c:strCache>
                <c:ptCount val="1"/>
                <c:pt idx="0">
                  <c:v>ADSC NORMA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Y$183:$Z$183</c:f>
                <c:numCache>
                  <c:formatCode>General</c:formatCode>
                  <c:ptCount val="2"/>
                  <c:pt idx="0">
                    <c:v>10.271914439051438</c:v>
                  </c:pt>
                  <c:pt idx="1">
                    <c:v>5.0000472129370301</c:v>
                  </c:pt>
                </c:numCache>
              </c:numRef>
            </c:plus>
            <c:minus>
              <c:numRef>
                <c:f>'ADSC FST'!$Y$183:$Z$183</c:f>
                <c:numCache>
                  <c:formatCode>General</c:formatCode>
                  <c:ptCount val="2"/>
                  <c:pt idx="0">
                    <c:v>10.271914439051438</c:v>
                  </c:pt>
                  <c:pt idx="1">
                    <c:v>5.0000472129370301</c:v>
                  </c:pt>
                </c:numCache>
              </c:numRef>
            </c:minus>
          </c:errBars>
          <c:cat>
            <c:strRef>
              <c:f>'ADSC FST'!$Y$175:$Z$175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FST'!$Y$178:$Z$178</c:f>
              <c:numCache>
                <c:formatCode>General</c:formatCode>
                <c:ptCount val="2"/>
                <c:pt idx="0">
                  <c:v>46.613959710508169</c:v>
                </c:pt>
                <c:pt idx="1">
                  <c:v>110.384141830053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093504"/>
        <c:axId val="179095040"/>
      </c:barChart>
      <c:catAx>
        <c:axId val="179093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9095040"/>
        <c:crosses val="autoZero"/>
        <c:auto val="1"/>
        <c:lblAlgn val="ctr"/>
        <c:lblOffset val="100"/>
        <c:noMultiLvlLbl val="0"/>
      </c:catAx>
      <c:valAx>
        <c:axId val="1790950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90935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FST'!$P$176</c:f>
              <c:strCache>
                <c:ptCount val="1"/>
                <c:pt idx="0">
                  <c:v>MES NORMA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FST'!$Q$175:$U$175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FST'!$Q$176:$U$176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FST'!$P$177</c:f>
              <c:strCache>
                <c:ptCount val="1"/>
                <c:pt idx="0">
                  <c:v>HMEC NORMA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Q$182:$U$182</c:f>
                <c:numCache>
                  <c:formatCode>General</c:formatCode>
                  <c:ptCount val="5"/>
                  <c:pt idx="0">
                    <c:v>3.881507793097385E-2</c:v>
                  </c:pt>
                  <c:pt idx="1">
                    <c:v>7.3380141589842379E-2</c:v>
                  </c:pt>
                  <c:pt idx="2">
                    <c:v>0.28043124166909866</c:v>
                  </c:pt>
                  <c:pt idx="3">
                    <c:v>0.43370576315120263</c:v>
                  </c:pt>
                  <c:pt idx="4">
                    <c:v>3.8470011957917258E-2</c:v>
                  </c:pt>
                </c:numCache>
              </c:numRef>
            </c:plus>
            <c:minus>
              <c:numRef>
                <c:f>'ADSC FST'!$Q$182:$U$182</c:f>
                <c:numCache>
                  <c:formatCode>General</c:formatCode>
                  <c:ptCount val="5"/>
                  <c:pt idx="0">
                    <c:v>3.881507793097385E-2</c:v>
                  </c:pt>
                  <c:pt idx="1">
                    <c:v>7.3380141589842379E-2</c:v>
                  </c:pt>
                  <c:pt idx="2">
                    <c:v>0.28043124166909866</c:v>
                  </c:pt>
                  <c:pt idx="3">
                    <c:v>0.43370576315120263</c:v>
                  </c:pt>
                  <c:pt idx="4">
                    <c:v>3.8470011957917258E-2</c:v>
                  </c:pt>
                </c:numCache>
              </c:numRef>
            </c:minus>
          </c:errBars>
          <c:cat>
            <c:strRef>
              <c:f>'ADSC FST'!$Q$175:$U$175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FST'!$Q$177:$U$177</c:f>
              <c:numCache>
                <c:formatCode>General</c:formatCode>
                <c:ptCount val="5"/>
                <c:pt idx="0">
                  <c:v>0.35867927716255421</c:v>
                </c:pt>
                <c:pt idx="1">
                  <c:v>0.93479594767093543</c:v>
                </c:pt>
                <c:pt idx="2">
                  <c:v>0.72389967896250373</c:v>
                </c:pt>
                <c:pt idx="3">
                  <c:v>1.5904906386976947</c:v>
                </c:pt>
                <c:pt idx="4">
                  <c:v>0.28109554747232102</c:v>
                </c:pt>
              </c:numCache>
            </c:numRef>
          </c:val>
        </c:ser>
        <c:ser>
          <c:idx val="2"/>
          <c:order val="2"/>
          <c:tx>
            <c:strRef>
              <c:f>'ADSC FST'!$P$178</c:f>
              <c:strCache>
                <c:ptCount val="1"/>
                <c:pt idx="0">
                  <c:v>ADSC NORMA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FST'!$Q$183:$U$183</c:f>
                <c:numCache>
                  <c:formatCode>General</c:formatCode>
                  <c:ptCount val="5"/>
                  <c:pt idx="0">
                    <c:v>0.41978621040996805</c:v>
                  </c:pt>
                  <c:pt idx="1">
                    <c:v>8.3038476076638444E-4</c:v>
                  </c:pt>
                  <c:pt idx="2">
                    <c:v>2.4581861073371463</c:v>
                  </c:pt>
                  <c:pt idx="3">
                    <c:v>0.53462995087037279</c:v>
                  </c:pt>
                  <c:pt idx="4">
                    <c:v>0.64031932735557884</c:v>
                  </c:pt>
                </c:numCache>
              </c:numRef>
            </c:plus>
            <c:minus>
              <c:numRef>
                <c:f>'ADSC FST'!$Q$183:$U$183</c:f>
                <c:numCache>
                  <c:formatCode>General</c:formatCode>
                  <c:ptCount val="5"/>
                  <c:pt idx="0">
                    <c:v>0.41978621040996805</c:v>
                  </c:pt>
                  <c:pt idx="1">
                    <c:v>8.3038476076638444E-4</c:v>
                  </c:pt>
                  <c:pt idx="2">
                    <c:v>2.4581861073371463</c:v>
                  </c:pt>
                  <c:pt idx="3">
                    <c:v>0.53462995087037279</c:v>
                  </c:pt>
                  <c:pt idx="4">
                    <c:v>0.64031932735557884</c:v>
                  </c:pt>
                </c:numCache>
              </c:numRef>
            </c:minus>
          </c:errBars>
          <c:cat>
            <c:strRef>
              <c:f>'ADSC FST'!$Q$175:$U$175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FST'!$Q$178:$U$178</c:f>
              <c:numCache>
                <c:formatCode>General</c:formatCode>
                <c:ptCount val="5"/>
                <c:pt idx="0">
                  <c:v>3.5286782232192131</c:v>
                </c:pt>
                <c:pt idx="1">
                  <c:v>5.0903170952957362E-3</c:v>
                </c:pt>
                <c:pt idx="2">
                  <c:v>6.2822946894351404</c:v>
                </c:pt>
                <c:pt idx="3">
                  <c:v>1.344046682837762</c:v>
                </c:pt>
                <c:pt idx="4">
                  <c:v>4.0836920462193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133824"/>
        <c:axId val="179139712"/>
      </c:barChart>
      <c:catAx>
        <c:axId val="179133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9139712"/>
        <c:crosses val="autoZero"/>
        <c:auto val="1"/>
        <c:lblAlgn val="ctr"/>
        <c:lblOffset val="100"/>
        <c:noMultiLvlLbl val="0"/>
      </c:catAx>
      <c:valAx>
        <c:axId val="1791397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91338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PS'!$P$179</c:f>
              <c:strCache>
                <c:ptCount val="1"/>
                <c:pt idx="0">
                  <c:v>MES IF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PS'!$Q$178:$U$178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PS'!$Q$179:$U$179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PS'!$P$180</c:f>
              <c:strCache>
                <c:ptCount val="1"/>
                <c:pt idx="0">
                  <c:v>HMEC IFDUC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Q$184:$U$184</c:f>
                <c:numCache>
                  <c:formatCode>General</c:formatCode>
                  <c:ptCount val="5"/>
                  <c:pt idx="0">
                    <c:v>2.8883261553718023E-3</c:v>
                  </c:pt>
                  <c:pt idx="1">
                    <c:v>2.599042622693359E-2</c:v>
                  </c:pt>
                  <c:pt idx="2">
                    <c:v>1.6077957576301359E-3</c:v>
                  </c:pt>
                  <c:pt idx="3">
                    <c:v>1.0517899403909476E-2</c:v>
                  </c:pt>
                  <c:pt idx="4">
                    <c:v>8.4823890260753657E-3</c:v>
                  </c:pt>
                </c:numCache>
              </c:numRef>
            </c:plus>
            <c:minus>
              <c:numRef>
                <c:f>'ADSC PS'!$Q$184:$U$184</c:f>
                <c:numCache>
                  <c:formatCode>General</c:formatCode>
                  <c:ptCount val="5"/>
                  <c:pt idx="0">
                    <c:v>2.8883261553718023E-3</c:v>
                  </c:pt>
                  <c:pt idx="1">
                    <c:v>2.599042622693359E-2</c:v>
                  </c:pt>
                  <c:pt idx="2">
                    <c:v>1.6077957576301359E-3</c:v>
                  </c:pt>
                  <c:pt idx="3">
                    <c:v>1.0517899403909476E-2</c:v>
                  </c:pt>
                  <c:pt idx="4">
                    <c:v>8.4823890260753657E-3</c:v>
                  </c:pt>
                </c:numCache>
              </c:numRef>
            </c:minus>
          </c:errBars>
          <c:cat>
            <c:strRef>
              <c:f>'ADSC PS'!$Q$178:$U$178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PS'!$Q$180:$U$180</c:f>
              <c:numCache>
                <c:formatCode>General</c:formatCode>
                <c:ptCount val="5"/>
                <c:pt idx="0">
                  <c:v>1.8783185895266317E-2</c:v>
                </c:pt>
                <c:pt idx="1">
                  <c:v>0.1553903292066309</c:v>
                </c:pt>
                <c:pt idx="2">
                  <c:v>7.6595441218947876E-3</c:v>
                </c:pt>
                <c:pt idx="3">
                  <c:v>4.0606357806957032E-2</c:v>
                </c:pt>
                <c:pt idx="4">
                  <c:v>1.8447025990532145E-2</c:v>
                </c:pt>
              </c:numCache>
            </c:numRef>
          </c:val>
        </c:ser>
        <c:ser>
          <c:idx val="2"/>
          <c:order val="2"/>
          <c:tx>
            <c:strRef>
              <c:f>'ADSC PS'!$P$181</c:f>
              <c:strCache>
                <c:ptCount val="1"/>
                <c:pt idx="0">
                  <c:v>ADSC IF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PS'!$Q$185:$U$185</c:f>
                <c:numCache>
                  <c:formatCode>General</c:formatCode>
                  <c:ptCount val="5"/>
                  <c:pt idx="0">
                    <c:v>0.15958783674886493</c:v>
                  </c:pt>
                  <c:pt idx="1">
                    <c:v>9.7141882398277951E-5</c:v>
                  </c:pt>
                  <c:pt idx="2">
                    <c:v>8.061523948700873E-2</c:v>
                  </c:pt>
                  <c:pt idx="3">
                    <c:v>2.5122571107805813E-2</c:v>
                  </c:pt>
                  <c:pt idx="4">
                    <c:v>0.25394693356976117</c:v>
                  </c:pt>
                </c:numCache>
              </c:numRef>
            </c:plus>
            <c:minus>
              <c:numRef>
                <c:f>'ADSC PS'!$Q$185:$U$185</c:f>
                <c:numCache>
                  <c:formatCode>General</c:formatCode>
                  <c:ptCount val="5"/>
                  <c:pt idx="0">
                    <c:v>0.15958783674886493</c:v>
                  </c:pt>
                  <c:pt idx="1">
                    <c:v>9.7141882398277951E-5</c:v>
                  </c:pt>
                  <c:pt idx="2">
                    <c:v>8.061523948700873E-2</c:v>
                  </c:pt>
                  <c:pt idx="3">
                    <c:v>2.5122571107805813E-2</c:v>
                  </c:pt>
                  <c:pt idx="4">
                    <c:v>0.25394693356976117</c:v>
                  </c:pt>
                </c:numCache>
              </c:numRef>
            </c:minus>
          </c:errBars>
          <c:cat>
            <c:strRef>
              <c:f>'ADSC PS'!$Q$178:$U$178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PS'!$Q$181:$U$181</c:f>
              <c:numCache>
                <c:formatCode>General</c:formatCode>
                <c:ptCount val="5"/>
                <c:pt idx="0">
                  <c:v>0.48272133193620115</c:v>
                </c:pt>
                <c:pt idx="1">
                  <c:v>6.8590079984303992E-4</c:v>
                </c:pt>
                <c:pt idx="2">
                  <c:v>0.37250163498477035</c:v>
                </c:pt>
                <c:pt idx="3">
                  <c:v>0.10373118185229095</c:v>
                </c:pt>
                <c:pt idx="4">
                  <c:v>1.09009467274741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441216"/>
        <c:axId val="176442752"/>
      </c:barChart>
      <c:catAx>
        <c:axId val="176441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6442752"/>
        <c:crosses val="autoZero"/>
        <c:auto val="1"/>
        <c:lblAlgn val="ctr"/>
        <c:lblOffset val="100"/>
        <c:noMultiLvlLbl val="0"/>
      </c:catAx>
      <c:valAx>
        <c:axId val="1764427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64412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EJ'!$Y$174</c:f>
              <c:strCache>
                <c:ptCount val="1"/>
                <c:pt idx="0">
                  <c:v>MES TRI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EJ'!$Z$173:$AA$173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EJ'!$Z$174:$AA$174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EJ'!$Y$175</c:f>
              <c:strCache>
                <c:ptCount val="1"/>
                <c:pt idx="0">
                  <c:v>ADSC TRI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EJ'!$Z$180:$AA$180</c:f>
                <c:numCache>
                  <c:formatCode>General</c:formatCode>
                  <c:ptCount val="2"/>
                  <c:pt idx="0">
                    <c:v>3.4482920990768107</c:v>
                  </c:pt>
                  <c:pt idx="1">
                    <c:v>0.5781982811906794</c:v>
                  </c:pt>
                </c:numCache>
              </c:numRef>
            </c:plus>
            <c:minus>
              <c:numRef>
                <c:f>'ADSC EJ'!$Z$180:$AA$180</c:f>
                <c:numCache>
                  <c:formatCode>General</c:formatCode>
                  <c:ptCount val="2"/>
                  <c:pt idx="0">
                    <c:v>3.4482920990768107</c:v>
                  </c:pt>
                  <c:pt idx="1">
                    <c:v>0.5781982811906794</c:v>
                  </c:pt>
                </c:numCache>
              </c:numRef>
            </c:minus>
          </c:errBars>
          <c:cat>
            <c:strRef>
              <c:f>'ADSC EJ'!$Z$173:$AA$173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EJ'!$Z$175:$AA$175</c:f>
              <c:numCache>
                <c:formatCode>General</c:formatCode>
                <c:ptCount val="2"/>
                <c:pt idx="0">
                  <c:v>18.737965107202498</c:v>
                </c:pt>
                <c:pt idx="1">
                  <c:v>2.35223115416834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472448"/>
        <c:axId val="176473984"/>
      </c:barChart>
      <c:catAx>
        <c:axId val="176472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6473984"/>
        <c:crosses val="autoZero"/>
        <c:auto val="1"/>
        <c:lblAlgn val="ctr"/>
        <c:lblOffset val="100"/>
        <c:noMultiLvlLbl val="0"/>
      </c:catAx>
      <c:valAx>
        <c:axId val="1764739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64724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EJ'!$Q$174</c:f>
              <c:strCache>
                <c:ptCount val="1"/>
                <c:pt idx="0">
                  <c:v>MES TRIDUC1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EJ'!$R$173:$V$173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EJ'!$R$174:$V$174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EJ'!$Q$175</c:f>
              <c:strCache>
                <c:ptCount val="1"/>
                <c:pt idx="0">
                  <c:v>ADSC TRIDUC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EJ'!$R$180:$V$180</c:f>
                <c:numCache>
                  <c:formatCode>General</c:formatCode>
                  <c:ptCount val="5"/>
                  <c:pt idx="0">
                    <c:v>0.16056719275413173</c:v>
                  </c:pt>
                  <c:pt idx="1">
                    <c:v>1.1145276724074479E-4</c:v>
                  </c:pt>
                  <c:pt idx="2">
                    <c:v>0.25900443276772689</c:v>
                  </c:pt>
                  <c:pt idx="3">
                    <c:v>6.1309307548472972E-3</c:v>
                  </c:pt>
                  <c:pt idx="4">
                    <c:v>0.27730457314932616</c:v>
                  </c:pt>
                </c:numCache>
              </c:numRef>
            </c:plus>
            <c:minus>
              <c:numRef>
                <c:f>'ADSC EJ'!$R$180:$V$180</c:f>
                <c:numCache>
                  <c:formatCode>General</c:formatCode>
                  <c:ptCount val="5"/>
                  <c:pt idx="0">
                    <c:v>0.16056719275413173</c:v>
                  </c:pt>
                  <c:pt idx="1">
                    <c:v>1.1145276724074479E-4</c:v>
                  </c:pt>
                  <c:pt idx="2">
                    <c:v>0.25900443276772689</c:v>
                  </c:pt>
                  <c:pt idx="3">
                    <c:v>6.1309307548472972E-3</c:v>
                  </c:pt>
                  <c:pt idx="4">
                    <c:v>0.27730457314932616</c:v>
                  </c:pt>
                </c:numCache>
              </c:numRef>
            </c:minus>
          </c:errBars>
          <c:cat>
            <c:strRef>
              <c:f>'ADSC EJ'!$R$173:$V$173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EJ'!$R$175:$V$175</c:f>
              <c:numCache>
                <c:formatCode>General</c:formatCode>
                <c:ptCount val="5"/>
                <c:pt idx="0">
                  <c:v>1.3496062052597935</c:v>
                </c:pt>
                <c:pt idx="1">
                  <c:v>4.2155479955458263E-4</c:v>
                </c:pt>
                <c:pt idx="2">
                  <c:v>1.1240035777518596</c:v>
                </c:pt>
                <c:pt idx="3">
                  <c:v>5.9463886975739351E-2</c:v>
                </c:pt>
                <c:pt idx="4">
                  <c:v>0.654000750422654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694784"/>
        <c:axId val="178696576"/>
      </c:barChart>
      <c:catAx>
        <c:axId val="178694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8696576"/>
        <c:crosses val="autoZero"/>
        <c:auto val="1"/>
        <c:lblAlgn val="ctr"/>
        <c:lblOffset val="100"/>
        <c:noMultiLvlLbl val="0"/>
      </c:catAx>
      <c:valAx>
        <c:axId val="1786965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86947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KB'!$X$178</c:f>
              <c:strCache>
                <c:ptCount val="1"/>
                <c:pt idx="0">
                  <c:v>MES NORMA4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Y$177:$Z$177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KB'!$Y$178:$Z$178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KB'!$X$179</c:f>
              <c:strCache>
                <c:ptCount val="1"/>
                <c:pt idx="0">
                  <c:v>HMEC NORMA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Y$177:$Z$177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KB'!$Y$179:$Z$179</c:f>
              <c:numCache>
                <c:formatCode>General</c:formatCode>
                <c:ptCount val="2"/>
                <c:pt idx="0">
                  <c:v>2.1396334263906625E-2</c:v>
                </c:pt>
                <c:pt idx="1">
                  <c:v>1.1062854033563413E-2</c:v>
                </c:pt>
              </c:numCache>
            </c:numRef>
          </c:val>
        </c:ser>
        <c:ser>
          <c:idx val="2"/>
          <c:order val="2"/>
          <c:tx>
            <c:strRef>
              <c:f>'ADSC KB'!$X$180</c:f>
              <c:strCache>
                <c:ptCount val="1"/>
                <c:pt idx="0">
                  <c:v>ADSC KB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DSC KB'!$Y$177:$Z$177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KB'!$Y$180:$Z$180</c:f>
              <c:numCache>
                <c:formatCode>General</c:formatCode>
                <c:ptCount val="2"/>
                <c:pt idx="0">
                  <c:v>14.362256834954659</c:v>
                </c:pt>
                <c:pt idx="1">
                  <c:v>1.38544271308526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727168"/>
        <c:axId val="178728960"/>
      </c:barChart>
      <c:catAx>
        <c:axId val="178727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8728960"/>
        <c:crosses val="autoZero"/>
        <c:auto val="1"/>
        <c:lblAlgn val="ctr"/>
        <c:lblOffset val="100"/>
        <c:noMultiLvlLbl val="0"/>
      </c:catAx>
      <c:valAx>
        <c:axId val="1787289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87271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KB'!$P$178</c:f>
              <c:strCache>
                <c:ptCount val="1"/>
                <c:pt idx="0">
                  <c:v>MES NORMA4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KB'!$Q$177:$U$177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KB'!$Q$178:$U$178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KB'!$P$179</c:f>
              <c:strCache>
                <c:ptCount val="1"/>
                <c:pt idx="0">
                  <c:v>HMEC NORMA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Q$183:$U$183</c:f>
                <c:numCache>
                  <c:formatCode>General</c:formatCode>
                  <c:ptCount val="5"/>
                  <c:pt idx="0">
                    <c:v>4.0296511073848081E-3</c:v>
                  </c:pt>
                  <c:pt idx="1">
                    <c:v>5.9811973571480659E-2</c:v>
                  </c:pt>
                  <c:pt idx="2">
                    <c:v>0.19482778186675215</c:v>
                  </c:pt>
                  <c:pt idx="3">
                    <c:v>3.4350388416196551E-3</c:v>
                  </c:pt>
                  <c:pt idx="4">
                    <c:v>4.3944893146802042E-2</c:v>
                  </c:pt>
                </c:numCache>
              </c:numRef>
            </c:plus>
            <c:minus>
              <c:numRef>
                <c:f>'ADSC KB'!$Q$183:$U$183</c:f>
                <c:numCache>
                  <c:formatCode>General</c:formatCode>
                  <c:ptCount val="5"/>
                  <c:pt idx="0">
                    <c:v>4.0296511073848081E-3</c:v>
                  </c:pt>
                  <c:pt idx="1">
                    <c:v>5.9811973571480659E-2</c:v>
                  </c:pt>
                  <c:pt idx="2">
                    <c:v>0.19482778186675215</c:v>
                  </c:pt>
                  <c:pt idx="3">
                    <c:v>3.4350388416196551E-3</c:v>
                  </c:pt>
                  <c:pt idx="4">
                    <c:v>4.3944893146802042E-2</c:v>
                  </c:pt>
                </c:numCache>
              </c:numRef>
            </c:minus>
          </c:errBars>
          <c:cat>
            <c:strRef>
              <c:f>'ADSC KB'!$Q$177:$U$177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KB'!$Q$179:$U$179</c:f>
              <c:numCache>
                <c:formatCode>General</c:formatCode>
                <c:ptCount val="5"/>
                <c:pt idx="0">
                  <c:v>2.8667051247804207E-2</c:v>
                </c:pt>
                <c:pt idx="1">
                  <c:v>0.40733571603148988</c:v>
                </c:pt>
                <c:pt idx="2">
                  <c:v>0.56711537269522805</c:v>
                </c:pt>
                <c:pt idx="3">
                  <c:v>1.336168239197809E-2</c:v>
                </c:pt>
                <c:pt idx="4">
                  <c:v>0.17202588849618197</c:v>
                </c:pt>
              </c:numCache>
            </c:numRef>
          </c:val>
        </c:ser>
        <c:ser>
          <c:idx val="2"/>
          <c:order val="2"/>
          <c:tx>
            <c:strRef>
              <c:f>'ADSC KB'!$P$180</c:f>
              <c:strCache>
                <c:ptCount val="1"/>
                <c:pt idx="0">
                  <c:v>ADSC KB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KB'!$Q$184:$U$184</c:f>
                <c:numCache>
                  <c:formatCode>General</c:formatCode>
                  <c:ptCount val="5"/>
                  <c:pt idx="0">
                    <c:v>0.43205145101240433</c:v>
                  </c:pt>
                  <c:pt idx="1">
                    <c:v>1.0805346212292581E-2</c:v>
                  </c:pt>
                  <c:pt idx="2">
                    <c:v>3.6365061595799846</c:v>
                  </c:pt>
                  <c:pt idx="3">
                    <c:v>2.976393830159247E-2</c:v>
                  </c:pt>
                  <c:pt idx="4">
                    <c:v>1.9955071511763818</c:v>
                  </c:pt>
                </c:numCache>
              </c:numRef>
            </c:plus>
            <c:minus>
              <c:numRef>
                <c:f>'ADSC KB'!$Q$184:$U$184</c:f>
                <c:numCache>
                  <c:formatCode>General</c:formatCode>
                  <c:ptCount val="5"/>
                  <c:pt idx="0">
                    <c:v>0.43205145101240433</c:v>
                  </c:pt>
                  <c:pt idx="1">
                    <c:v>1.0805346212292581E-2</c:v>
                  </c:pt>
                  <c:pt idx="2">
                    <c:v>3.6365061595799846</c:v>
                  </c:pt>
                  <c:pt idx="3">
                    <c:v>2.976393830159247E-2</c:v>
                  </c:pt>
                  <c:pt idx="4">
                    <c:v>1.9955071511763818</c:v>
                  </c:pt>
                </c:numCache>
              </c:numRef>
            </c:minus>
          </c:errBars>
          <c:cat>
            <c:strRef>
              <c:f>'ADSC KB'!$Q$177:$U$177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KB'!$Q$180:$U$180</c:f>
              <c:numCache>
                <c:formatCode>General</c:formatCode>
                <c:ptCount val="5"/>
                <c:pt idx="0">
                  <c:v>2.0754424116349983</c:v>
                </c:pt>
                <c:pt idx="1">
                  <c:v>3.191878859265302E-2</c:v>
                </c:pt>
                <c:pt idx="2">
                  <c:v>6.7263086607052047</c:v>
                </c:pt>
                <c:pt idx="3">
                  <c:v>0.23764744104728641</c:v>
                </c:pt>
                <c:pt idx="4">
                  <c:v>8.3077142572069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796416"/>
        <c:axId val="178797952"/>
      </c:barChart>
      <c:catAx>
        <c:axId val="178796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8797952"/>
        <c:crosses val="autoZero"/>
        <c:auto val="1"/>
        <c:lblAlgn val="ctr"/>
        <c:lblOffset val="100"/>
        <c:noMultiLvlLbl val="0"/>
      </c:catAx>
      <c:valAx>
        <c:axId val="1787979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87964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MBE'!$W$177</c:f>
              <c:strCache>
                <c:ptCount val="1"/>
                <c:pt idx="0">
                  <c:v>MES NORMA3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MBE'!$X$176:$Y$176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MBE'!$X$177:$Y$177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MBE'!$W$178</c:f>
              <c:strCache>
                <c:ptCount val="1"/>
                <c:pt idx="0">
                  <c:v>HMEC NORMA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X$182:$Y$182</c:f>
                <c:numCache>
                  <c:formatCode>General</c:formatCode>
                  <c:ptCount val="2"/>
                  <c:pt idx="0">
                    <c:v>6.2588014304301486E-3</c:v>
                  </c:pt>
                  <c:pt idx="1">
                    <c:v>0.52556961404385405</c:v>
                  </c:pt>
                </c:numCache>
              </c:numRef>
            </c:plus>
            <c:minus>
              <c:numRef>
                <c:f>'ADSC MBE'!$X$182:$Y$182</c:f>
                <c:numCache>
                  <c:formatCode>General</c:formatCode>
                  <c:ptCount val="2"/>
                  <c:pt idx="0">
                    <c:v>6.2588014304301486E-3</c:v>
                  </c:pt>
                  <c:pt idx="1">
                    <c:v>0.52556961404385405</c:v>
                  </c:pt>
                </c:numCache>
              </c:numRef>
            </c:minus>
          </c:errBars>
          <c:cat>
            <c:strRef>
              <c:f>'ADSC MBE'!$X$176:$Y$176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MBE'!$X$178:$Y$178</c:f>
              <c:numCache>
                <c:formatCode>General</c:formatCode>
                <c:ptCount val="2"/>
                <c:pt idx="0">
                  <c:v>9.5131792436084536E-2</c:v>
                </c:pt>
                <c:pt idx="1">
                  <c:v>2.7564383839432653</c:v>
                </c:pt>
              </c:numCache>
            </c:numRef>
          </c:val>
        </c:ser>
        <c:ser>
          <c:idx val="2"/>
          <c:order val="2"/>
          <c:tx>
            <c:strRef>
              <c:f>'ADSC MBE'!$W$179</c:f>
              <c:strCache>
                <c:ptCount val="1"/>
                <c:pt idx="0">
                  <c:v>ADSC NORMA3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X$183:$Y$183</c:f>
                <c:numCache>
                  <c:formatCode>General</c:formatCode>
                  <c:ptCount val="2"/>
                  <c:pt idx="0">
                    <c:v>1.6441476149477403</c:v>
                  </c:pt>
                  <c:pt idx="1">
                    <c:v>1.8301100116176694</c:v>
                  </c:pt>
                </c:numCache>
              </c:numRef>
            </c:plus>
            <c:minus>
              <c:numRef>
                <c:f>'ADSC MBE'!$X$183:$Y$183</c:f>
                <c:numCache>
                  <c:formatCode>General</c:formatCode>
                  <c:ptCount val="2"/>
                  <c:pt idx="0">
                    <c:v>1.6441476149477403</c:v>
                  </c:pt>
                  <c:pt idx="1">
                    <c:v>1.8301100116176694</c:v>
                  </c:pt>
                </c:numCache>
              </c:numRef>
            </c:minus>
          </c:errBars>
          <c:cat>
            <c:strRef>
              <c:f>'ADSC MBE'!$X$176:$Y$176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MBE'!$X$179:$Y$179</c:f>
              <c:numCache>
                <c:formatCode>General</c:formatCode>
                <c:ptCount val="2"/>
                <c:pt idx="0">
                  <c:v>23.816790807834124</c:v>
                </c:pt>
                <c:pt idx="1">
                  <c:v>10.4079018373526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828800"/>
        <c:axId val="178830336"/>
      </c:barChart>
      <c:catAx>
        <c:axId val="178828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8830336"/>
        <c:crosses val="autoZero"/>
        <c:auto val="1"/>
        <c:lblAlgn val="ctr"/>
        <c:lblOffset val="100"/>
        <c:noMultiLvlLbl val="0"/>
      </c:catAx>
      <c:valAx>
        <c:axId val="1788303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8828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MBE'!$P$177</c:f>
              <c:strCache>
                <c:ptCount val="1"/>
                <c:pt idx="0">
                  <c:v>MES NORMA3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MBE'!$Q$176:$U$176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MBE'!$Q$177:$U$177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MBE'!$P$178</c:f>
              <c:strCache>
                <c:ptCount val="1"/>
                <c:pt idx="0">
                  <c:v>HMEC NORMA3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Q$182:$U$182</c:f>
                <c:numCache>
                  <c:formatCode>General</c:formatCode>
                  <c:ptCount val="5"/>
                  <c:pt idx="0">
                    <c:v>1.8614938523967728E-3</c:v>
                  </c:pt>
                  <c:pt idx="1">
                    <c:v>5.8195997002610036E-2</c:v>
                  </c:pt>
                  <c:pt idx="2">
                    <c:v>3.5202430072916284E-3</c:v>
                  </c:pt>
                  <c:pt idx="3">
                    <c:v>0.19990355968672913</c:v>
                  </c:pt>
                  <c:pt idx="4">
                    <c:v>1.1476283329707536E-2</c:v>
                  </c:pt>
                </c:numCache>
              </c:numRef>
            </c:plus>
            <c:minus>
              <c:numRef>
                <c:f>'ADSC MBE'!$Q$182:$U$182</c:f>
                <c:numCache>
                  <c:formatCode>General</c:formatCode>
                  <c:ptCount val="5"/>
                  <c:pt idx="0">
                    <c:v>1.8614938523967728E-3</c:v>
                  </c:pt>
                  <c:pt idx="1">
                    <c:v>5.8195997002610036E-2</c:v>
                  </c:pt>
                  <c:pt idx="2">
                    <c:v>3.5202430072916284E-3</c:v>
                  </c:pt>
                  <c:pt idx="3">
                    <c:v>0.19990355968672913</c:v>
                  </c:pt>
                  <c:pt idx="4">
                    <c:v>1.1476283329707536E-2</c:v>
                  </c:pt>
                </c:numCache>
              </c:numRef>
            </c:minus>
          </c:errBars>
          <c:cat>
            <c:strRef>
              <c:f>'ADSC MBE'!$Q$176:$U$176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MBE'!$Q$178:$U$178</c:f>
              <c:numCache>
                <c:formatCode>General</c:formatCode>
                <c:ptCount val="5"/>
                <c:pt idx="0">
                  <c:v>0.18515595147335126</c:v>
                </c:pt>
                <c:pt idx="1">
                  <c:v>0.12700890869458137</c:v>
                </c:pt>
                <c:pt idx="2">
                  <c:v>4.7423559796515947E-2</c:v>
                </c:pt>
                <c:pt idx="3">
                  <c:v>0.9501449681509101</c:v>
                </c:pt>
                <c:pt idx="4">
                  <c:v>5.703014351958019E-2</c:v>
                </c:pt>
              </c:numCache>
            </c:numRef>
          </c:val>
        </c:ser>
        <c:ser>
          <c:idx val="2"/>
          <c:order val="2"/>
          <c:tx>
            <c:strRef>
              <c:f>'ADSC MBE'!$P$179</c:f>
              <c:strCache>
                <c:ptCount val="1"/>
                <c:pt idx="0">
                  <c:v>ADSC NORMA3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MBE'!$Q$183:$U$183</c:f>
                <c:numCache>
                  <c:formatCode>General</c:formatCode>
                  <c:ptCount val="5"/>
                  <c:pt idx="0">
                    <c:v>0.20096607314256687</c:v>
                  </c:pt>
                  <c:pt idx="1">
                    <c:v>0.18597375638854063</c:v>
                  </c:pt>
                  <c:pt idx="2">
                    <c:v>2.0776311899504369E-2</c:v>
                  </c:pt>
                  <c:pt idx="3">
                    <c:v>0.17828245144057384</c:v>
                  </c:pt>
                  <c:pt idx="4">
                    <c:v>0.28740670198125334</c:v>
                  </c:pt>
                </c:numCache>
              </c:numRef>
            </c:plus>
            <c:minus>
              <c:numRef>
                <c:f>'ADSC MBE'!$Q$183:$U$183</c:f>
                <c:numCache>
                  <c:formatCode>General</c:formatCode>
                  <c:ptCount val="5"/>
                  <c:pt idx="0">
                    <c:v>0.20096607314256687</c:v>
                  </c:pt>
                  <c:pt idx="1">
                    <c:v>0.18597375638854063</c:v>
                  </c:pt>
                  <c:pt idx="2">
                    <c:v>2.0776311899504369E-2</c:v>
                  </c:pt>
                  <c:pt idx="3">
                    <c:v>0.17828245144057384</c:v>
                  </c:pt>
                  <c:pt idx="4">
                    <c:v>0.28740670198125334</c:v>
                  </c:pt>
                </c:numCache>
              </c:numRef>
            </c:minus>
          </c:errBars>
          <c:cat>
            <c:strRef>
              <c:f>'ADSC MBE'!$Q$176:$U$176</c:f>
              <c:strCache>
                <c:ptCount val="5"/>
                <c:pt idx="0">
                  <c:v>MMP2</c:v>
                </c:pt>
                <c:pt idx="1">
                  <c:v>MMP9</c:v>
                </c:pt>
                <c:pt idx="2">
                  <c:v>SNAI1</c:v>
                </c:pt>
                <c:pt idx="3">
                  <c:v>ARHGAP22</c:v>
                </c:pt>
                <c:pt idx="4">
                  <c:v>S100A4</c:v>
                </c:pt>
              </c:strCache>
            </c:strRef>
          </c:cat>
          <c:val>
            <c:numRef>
              <c:f>'ADSC MBE'!$Q$179:$U$179</c:f>
              <c:numCache>
                <c:formatCode>General</c:formatCode>
                <c:ptCount val="5"/>
                <c:pt idx="0">
                  <c:v>2.4611851463684418</c:v>
                </c:pt>
                <c:pt idx="1">
                  <c:v>0.99523742469317111</c:v>
                </c:pt>
                <c:pt idx="2">
                  <c:v>0.12018255993954474</c:v>
                </c:pt>
                <c:pt idx="3">
                  <c:v>1.0620944381012911</c:v>
                </c:pt>
                <c:pt idx="4">
                  <c:v>2.65257947541060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898048"/>
        <c:axId val="178899584"/>
      </c:barChart>
      <c:catAx>
        <c:axId val="178898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8899584"/>
        <c:crosses val="autoZero"/>
        <c:auto val="1"/>
        <c:lblAlgn val="ctr"/>
        <c:lblOffset val="100"/>
        <c:noMultiLvlLbl val="0"/>
      </c:catAx>
      <c:valAx>
        <c:axId val="1788995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8898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DSC SLA'!$X$177</c:f>
              <c:strCache>
                <c:ptCount val="1"/>
                <c:pt idx="0">
                  <c:v>MES NORMA2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errBars>
            <c:errBarType val="both"/>
            <c:errValType val="stdDev"/>
            <c:noEndCap val="0"/>
            <c:val val="1"/>
          </c:errBars>
          <c:cat>
            <c:strRef>
              <c:f>'ADSC SLA'!$Y$176:$Z$176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SLA'!$Y$177:$Z$177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ADSC SLA'!$X$178</c:f>
              <c:strCache>
                <c:ptCount val="1"/>
                <c:pt idx="0">
                  <c:v>HMEC NORMA2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Y$182:$Z$182</c:f>
                <c:numCache>
                  <c:formatCode>General</c:formatCode>
                  <c:ptCount val="2"/>
                  <c:pt idx="0">
                    <c:v>0.15051907514652574</c:v>
                  </c:pt>
                  <c:pt idx="1">
                    <c:v>0.15180518960923298</c:v>
                  </c:pt>
                </c:numCache>
              </c:numRef>
            </c:plus>
            <c:minus>
              <c:numRef>
                <c:f>'ADSC SLA'!$Y$182:$Z$182</c:f>
                <c:numCache>
                  <c:formatCode>General</c:formatCode>
                  <c:ptCount val="2"/>
                  <c:pt idx="0">
                    <c:v>0.15051907514652574</c:v>
                  </c:pt>
                  <c:pt idx="1">
                    <c:v>0.15180518960923298</c:v>
                  </c:pt>
                </c:numCache>
              </c:numRef>
            </c:minus>
          </c:errBars>
          <c:cat>
            <c:strRef>
              <c:f>'ADSC SLA'!$Y$176:$Z$176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SLA'!$Y$178:$Z$178</c:f>
              <c:numCache>
                <c:formatCode>General</c:formatCode>
                <c:ptCount val="2"/>
                <c:pt idx="0">
                  <c:v>0.69331125885487255</c:v>
                </c:pt>
                <c:pt idx="1">
                  <c:v>0.61136587290452182</c:v>
                </c:pt>
              </c:numCache>
            </c:numRef>
          </c:val>
        </c:ser>
        <c:ser>
          <c:idx val="2"/>
          <c:order val="2"/>
          <c:tx>
            <c:strRef>
              <c:f>'ADSC SLA'!$X$179</c:f>
              <c:strCache>
                <c:ptCount val="1"/>
                <c:pt idx="0">
                  <c:v>ADSC NORMA2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DSC SLA'!$Y$183:$Z$183</c:f>
                <c:numCache>
                  <c:formatCode>General</c:formatCode>
                  <c:ptCount val="2"/>
                  <c:pt idx="0">
                    <c:v>34.297943033340104</c:v>
                  </c:pt>
                  <c:pt idx="1">
                    <c:v>8.2923174520920995</c:v>
                  </c:pt>
                </c:numCache>
              </c:numRef>
            </c:plus>
            <c:minus>
              <c:numRef>
                <c:f>'ADSC SLA'!$Y$183:$Z$183</c:f>
                <c:numCache>
                  <c:formatCode>General</c:formatCode>
                  <c:ptCount val="2"/>
                  <c:pt idx="0">
                    <c:v>34.297943033340104</c:v>
                  </c:pt>
                  <c:pt idx="1">
                    <c:v>8.2923174520920995</c:v>
                  </c:pt>
                </c:numCache>
              </c:numRef>
            </c:minus>
          </c:errBars>
          <c:cat>
            <c:strRef>
              <c:f>'ADSC SLA'!$Y$176:$Z$176</c:f>
              <c:strCache>
                <c:ptCount val="2"/>
                <c:pt idx="0">
                  <c:v>CDH2</c:v>
                </c:pt>
                <c:pt idx="1">
                  <c:v>CDH11</c:v>
                </c:pt>
              </c:strCache>
            </c:strRef>
          </c:cat>
          <c:val>
            <c:numRef>
              <c:f>'ADSC SLA'!$Y$179:$Z$179</c:f>
              <c:numCache>
                <c:formatCode>General</c:formatCode>
                <c:ptCount val="2"/>
                <c:pt idx="0">
                  <c:v>103.13143587335061</c:v>
                </c:pt>
                <c:pt idx="1">
                  <c:v>19.2746474472855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959104"/>
        <c:axId val="178960640"/>
      </c:barChart>
      <c:catAx>
        <c:axId val="178959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8960640"/>
        <c:crosses val="autoZero"/>
        <c:auto val="1"/>
        <c:lblAlgn val="ctr"/>
        <c:lblOffset val="100"/>
        <c:noMultiLvlLbl val="0"/>
      </c:catAx>
      <c:valAx>
        <c:axId val="1789606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89591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4552" cy="499824"/>
          </a:xfrm>
          <a:prstGeom prst="rect">
            <a:avLst/>
          </a:prstGeom>
        </p:spPr>
        <p:txBody>
          <a:bodyPr vert="horz" lIns="92144" tIns="46072" rIns="92144" bIns="46072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8210" y="1"/>
            <a:ext cx="2974552" cy="499824"/>
          </a:xfrm>
          <a:prstGeom prst="rect">
            <a:avLst/>
          </a:prstGeom>
        </p:spPr>
        <p:txBody>
          <a:bodyPr vert="horz" lIns="92144" tIns="46072" rIns="92144" bIns="46072" rtlCol="0"/>
          <a:lstStyle>
            <a:lvl1pPr algn="r">
              <a:defRPr sz="1200"/>
            </a:lvl1pPr>
          </a:lstStyle>
          <a:p>
            <a:fld id="{C4BD3008-0BE9-4A41-9510-3695C8385C78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33450" y="749300"/>
            <a:ext cx="49974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44" tIns="46072" rIns="92144" bIns="46072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6435" y="4748332"/>
            <a:ext cx="5491480" cy="4498419"/>
          </a:xfrm>
          <a:prstGeom prst="rect">
            <a:avLst/>
          </a:prstGeom>
        </p:spPr>
        <p:txBody>
          <a:bodyPr vert="horz" lIns="92144" tIns="46072" rIns="92144" bIns="46072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94929"/>
            <a:ext cx="2974552" cy="499824"/>
          </a:xfrm>
          <a:prstGeom prst="rect">
            <a:avLst/>
          </a:prstGeom>
        </p:spPr>
        <p:txBody>
          <a:bodyPr vert="horz" lIns="92144" tIns="46072" rIns="92144" bIns="46072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8210" y="9494929"/>
            <a:ext cx="2974552" cy="499824"/>
          </a:xfrm>
          <a:prstGeom prst="rect">
            <a:avLst/>
          </a:prstGeom>
        </p:spPr>
        <p:txBody>
          <a:bodyPr vert="horz" lIns="92144" tIns="46072" rIns="92144" bIns="46072" rtlCol="0" anchor="b"/>
          <a:lstStyle>
            <a:lvl1pPr algn="r">
              <a:defRPr sz="1200"/>
            </a:lvl1pPr>
          </a:lstStyle>
          <a:p>
            <a:fld id="{2E44BE97-5C19-44A2-85E8-B9DD929E20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48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972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910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211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5650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658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1874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5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484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3330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389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583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0C913-2F9E-49E4-8047-720020B0768F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A043D-660F-4C7E-9607-29F75988D6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2528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0" name="Gruppieren 139"/>
          <p:cNvGrpSpPr/>
          <p:nvPr/>
        </p:nvGrpSpPr>
        <p:grpSpPr>
          <a:xfrm>
            <a:off x="1170552" y="-171399"/>
            <a:ext cx="6281768" cy="7079896"/>
            <a:chOff x="1170552" y="-171399"/>
            <a:chExt cx="6281768" cy="7079896"/>
          </a:xfrm>
        </p:grpSpPr>
        <p:graphicFrame>
          <p:nvGraphicFramePr>
            <p:cNvPr id="2" name="Diagramm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96947046"/>
                </p:ext>
              </p:extLst>
            </p:nvPr>
          </p:nvGraphicFramePr>
          <p:xfrm>
            <a:off x="5641200" y="5589240"/>
            <a:ext cx="1476000" cy="11139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Diagramm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45515686"/>
                </p:ext>
              </p:extLst>
            </p:nvPr>
          </p:nvGraphicFramePr>
          <p:xfrm>
            <a:off x="1742400" y="5544000"/>
            <a:ext cx="3996000" cy="115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Diagramm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85662035"/>
                </p:ext>
              </p:extLst>
            </p:nvPr>
          </p:nvGraphicFramePr>
          <p:xfrm>
            <a:off x="5641200" y="4442400"/>
            <a:ext cx="1440000" cy="11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Diagramm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3468049"/>
                </p:ext>
              </p:extLst>
            </p:nvPr>
          </p:nvGraphicFramePr>
          <p:xfrm>
            <a:off x="1742400" y="4482000"/>
            <a:ext cx="3996000" cy="115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Diagramm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48559884"/>
                </p:ext>
              </p:extLst>
            </p:nvPr>
          </p:nvGraphicFramePr>
          <p:xfrm>
            <a:off x="5641200" y="3405600"/>
            <a:ext cx="1440000" cy="117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Diagramm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5392118"/>
                </p:ext>
              </p:extLst>
            </p:nvPr>
          </p:nvGraphicFramePr>
          <p:xfrm>
            <a:off x="1778400" y="3492000"/>
            <a:ext cx="3960000" cy="10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" name="Diagramm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22137865"/>
                </p:ext>
              </p:extLst>
            </p:nvPr>
          </p:nvGraphicFramePr>
          <p:xfrm>
            <a:off x="5641200" y="2322000"/>
            <a:ext cx="1404000" cy="1166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" name="Diagramm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32851258"/>
                </p:ext>
              </p:extLst>
            </p:nvPr>
          </p:nvGraphicFramePr>
          <p:xfrm>
            <a:off x="1836000" y="2340000"/>
            <a:ext cx="3888000" cy="1148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0" name="Diagramm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65820759"/>
                </p:ext>
              </p:extLst>
            </p:nvPr>
          </p:nvGraphicFramePr>
          <p:xfrm>
            <a:off x="5580000" y="1310400"/>
            <a:ext cx="1512000" cy="10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1" name="Diagramm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85710074"/>
                </p:ext>
              </p:extLst>
            </p:nvPr>
          </p:nvGraphicFramePr>
          <p:xfrm>
            <a:off x="1782128" y="1332000"/>
            <a:ext cx="3942000" cy="1058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12" name="Diagramm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48879390"/>
                </p:ext>
              </p:extLst>
            </p:nvPr>
          </p:nvGraphicFramePr>
          <p:xfrm>
            <a:off x="5580280" y="186800"/>
            <a:ext cx="1512000" cy="115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13" name="Diagramm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67148901"/>
                </p:ext>
              </p:extLst>
            </p:nvPr>
          </p:nvGraphicFramePr>
          <p:xfrm>
            <a:off x="1782128" y="260768"/>
            <a:ext cx="3942000" cy="10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14" name="Textfeld 13"/>
            <p:cNvSpPr txBox="1"/>
            <p:nvPr/>
          </p:nvSpPr>
          <p:spPr>
            <a:xfrm rot="16200000">
              <a:off x="1224552" y="611758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 rot="16200000">
              <a:off x="1224552" y="503746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 rot="16200000">
              <a:off x="1224552" y="395734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6200000">
              <a:off x="1224552" y="287722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 rot="16200000">
              <a:off x="1224552" y="179710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 rot="16200000">
              <a:off x="1224552" y="716989"/>
              <a:ext cx="87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1476552" y="188641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476552" y="127979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1476552" y="235991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1476552" y="3429001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476552" y="452015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1476552" y="5600274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" name="Gruppieren 25"/>
            <p:cNvGrpSpPr/>
            <p:nvPr/>
          </p:nvGrpSpPr>
          <p:grpSpPr>
            <a:xfrm>
              <a:off x="2339752" y="576000"/>
              <a:ext cx="522600" cy="495900"/>
              <a:chOff x="3402296" y="2664232"/>
              <a:chExt cx="522600" cy="495900"/>
            </a:xfrm>
          </p:grpSpPr>
          <p:sp>
            <p:nvSpPr>
              <p:cNvPr id="27" name="Textfeld 26"/>
              <p:cNvSpPr txBox="1"/>
              <p:nvPr/>
            </p:nvSpPr>
            <p:spPr>
              <a:xfrm>
                <a:off x="3402296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>
                <a:off x="3528544" y="266423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29" name="Textfeld 28"/>
            <p:cNvSpPr txBox="1"/>
            <p:nvPr/>
          </p:nvSpPr>
          <p:spPr>
            <a:xfrm>
              <a:off x="3167536" y="863134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3859200" y="260648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31" name="Gruppieren 30"/>
            <p:cNvGrpSpPr/>
            <p:nvPr/>
          </p:nvGrpSpPr>
          <p:grpSpPr>
            <a:xfrm>
              <a:off x="5111752" y="548680"/>
              <a:ext cx="551400" cy="504057"/>
              <a:chOff x="3395080" y="2708920"/>
              <a:chExt cx="551400" cy="504057"/>
            </a:xfrm>
          </p:grpSpPr>
          <p:sp>
            <p:nvSpPr>
              <p:cNvPr id="32" name="Textfeld 31"/>
              <p:cNvSpPr txBox="1"/>
              <p:nvPr/>
            </p:nvSpPr>
            <p:spPr>
              <a:xfrm>
                <a:off x="3395080" y="2951367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3550128" y="270892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4" name="Gruppieren 33"/>
            <p:cNvGrpSpPr/>
            <p:nvPr/>
          </p:nvGrpSpPr>
          <p:grpSpPr>
            <a:xfrm>
              <a:off x="2310656" y="2538000"/>
              <a:ext cx="548096" cy="720562"/>
              <a:chOff x="3402296" y="2773188"/>
              <a:chExt cx="548096" cy="720562"/>
            </a:xfrm>
          </p:grpSpPr>
          <p:sp>
            <p:nvSpPr>
              <p:cNvPr id="35" name="Textfeld 34"/>
              <p:cNvSpPr txBox="1"/>
              <p:nvPr/>
            </p:nvSpPr>
            <p:spPr>
              <a:xfrm>
                <a:off x="3402296" y="323214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3554040" y="277318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37" name="Gruppieren 36"/>
            <p:cNvGrpSpPr/>
            <p:nvPr/>
          </p:nvGrpSpPr>
          <p:grpSpPr>
            <a:xfrm>
              <a:off x="3708000" y="3023374"/>
              <a:ext cx="554752" cy="261610"/>
              <a:chOff x="3402296" y="2898522"/>
              <a:chExt cx="554752" cy="261610"/>
            </a:xfrm>
          </p:grpSpPr>
          <p:sp>
            <p:nvSpPr>
              <p:cNvPr id="38" name="Textfeld 37"/>
              <p:cNvSpPr txBox="1"/>
              <p:nvPr/>
            </p:nvSpPr>
            <p:spPr>
              <a:xfrm>
                <a:off x="3402296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3560696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40" name="Textfeld 39"/>
            <p:cNvSpPr txBox="1"/>
            <p:nvPr/>
          </p:nvSpPr>
          <p:spPr>
            <a:xfrm>
              <a:off x="3006000" y="2996952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41" name="Gruppieren 40"/>
            <p:cNvGrpSpPr/>
            <p:nvPr/>
          </p:nvGrpSpPr>
          <p:grpSpPr>
            <a:xfrm>
              <a:off x="5112000" y="2484000"/>
              <a:ext cx="547552" cy="800984"/>
              <a:chOff x="3402296" y="2529586"/>
              <a:chExt cx="547552" cy="800984"/>
            </a:xfrm>
          </p:grpSpPr>
          <p:sp>
            <p:nvSpPr>
              <p:cNvPr id="42" name="Textfeld 41"/>
              <p:cNvSpPr txBox="1"/>
              <p:nvPr/>
            </p:nvSpPr>
            <p:spPr>
              <a:xfrm>
                <a:off x="3402296" y="306896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3553496" y="252958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4" name="Gruppieren 43"/>
            <p:cNvGrpSpPr/>
            <p:nvPr/>
          </p:nvGrpSpPr>
          <p:grpSpPr>
            <a:xfrm>
              <a:off x="2314800" y="4005064"/>
              <a:ext cx="547552" cy="360040"/>
              <a:chOff x="3377344" y="2898522"/>
              <a:chExt cx="547552" cy="360040"/>
            </a:xfrm>
          </p:grpSpPr>
          <p:sp>
            <p:nvSpPr>
              <p:cNvPr id="45" name="Textfeld 44"/>
              <p:cNvSpPr txBox="1"/>
              <p:nvPr/>
            </p:nvSpPr>
            <p:spPr>
              <a:xfrm>
                <a:off x="3377344" y="299695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3528544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47" name="Gruppieren 46"/>
            <p:cNvGrpSpPr/>
            <p:nvPr/>
          </p:nvGrpSpPr>
          <p:grpSpPr>
            <a:xfrm>
              <a:off x="3024000" y="4104000"/>
              <a:ext cx="539888" cy="261610"/>
              <a:chOff x="3395560" y="2925450"/>
              <a:chExt cx="539888" cy="261610"/>
            </a:xfrm>
          </p:grpSpPr>
          <p:sp>
            <p:nvSpPr>
              <p:cNvPr id="48" name="Textfeld 47"/>
              <p:cNvSpPr txBox="1"/>
              <p:nvPr/>
            </p:nvSpPr>
            <p:spPr>
              <a:xfrm>
                <a:off x="3395560" y="29254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49" name="Textfeld 48"/>
              <p:cNvSpPr txBox="1"/>
              <p:nvPr/>
            </p:nvSpPr>
            <p:spPr>
              <a:xfrm>
                <a:off x="3539096" y="292545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0" name="Gruppieren 49"/>
            <p:cNvGrpSpPr/>
            <p:nvPr/>
          </p:nvGrpSpPr>
          <p:grpSpPr>
            <a:xfrm>
              <a:off x="4428000" y="4103494"/>
              <a:ext cx="551152" cy="261610"/>
              <a:chOff x="3359400" y="2898522"/>
              <a:chExt cx="551152" cy="261610"/>
            </a:xfrm>
          </p:grpSpPr>
          <p:sp>
            <p:nvSpPr>
              <p:cNvPr id="51" name="Textfeld 50"/>
              <p:cNvSpPr txBox="1"/>
              <p:nvPr/>
            </p:nvSpPr>
            <p:spPr>
              <a:xfrm>
                <a:off x="3359400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3514200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3" name="Gruppieren 52"/>
            <p:cNvGrpSpPr/>
            <p:nvPr/>
          </p:nvGrpSpPr>
          <p:grpSpPr>
            <a:xfrm>
              <a:off x="5115600" y="3672000"/>
              <a:ext cx="558352" cy="693104"/>
              <a:chOff x="3398928" y="2827068"/>
              <a:chExt cx="558352" cy="693104"/>
            </a:xfrm>
          </p:grpSpPr>
          <p:sp>
            <p:nvSpPr>
              <p:cNvPr id="54" name="Textfeld 53"/>
              <p:cNvSpPr txBox="1"/>
              <p:nvPr/>
            </p:nvSpPr>
            <p:spPr>
              <a:xfrm>
                <a:off x="3398928" y="325856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3560928" y="282706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6" name="Gruppieren 55"/>
            <p:cNvGrpSpPr/>
            <p:nvPr/>
          </p:nvGrpSpPr>
          <p:grpSpPr>
            <a:xfrm>
              <a:off x="2304000" y="5903694"/>
              <a:ext cx="558600" cy="595228"/>
              <a:chOff x="3402296" y="2872100"/>
              <a:chExt cx="558600" cy="595228"/>
            </a:xfrm>
          </p:grpSpPr>
          <p:sp>
            <p:nvSpPr>
              <p:cNvPr id="57" name="Textfeld 56"/>
              <p:cNvSpPr txBox="1"/>
              <p:nvPr/>
            </p:nvSpPr>
            <p:spPr>
              <a:xfrm>
                <a:off x="3402296" y="320571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>
                <a:off x="3564544" y="28721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59" name="Gruppieren 58"/>
            <p:cNvGrpSpPr/>
            <p:nvPr/>
          </p:nvGrpSpPr>
          <p:grpSpPr>
            <a:xfrm>
              <a:off x="3024000" y="6165304"/>
              <a:ext cx="533152" cy="307196"/>
              <a:chOff x="3402296" y="2898522"/>
              <a:chExt cx="533152" cy="307196"/>
            </a:xfrm>
          </p:grpSpPr>
          <p:sp>
            <p:nvSpPr>
              <p:cNvPr id="60" name="Textfeld 59"/>
              <p:cNvSpPr txBox="1"/>
              <p:nvPr/>
            </p:nvSpPr>
            <p:spPr>
              <a:xfrm>
                <a:off x="3402296" y="289852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3539096" y="294410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62" name="Textfeld 61"/>
            <p:cNvSpPr txBox="1"/>
            <p:nvPr/>
          </p:nvSpPr>
          <p:spPr>
            <a:xfrm>
              <a:off x="3870000" y="6021288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63" name="Gruppieren 62"/>
            <p:cNvGrpSpPr/>
            <p:nvPr/>
          </p:nvGrpSpPr>
          <p:grpSpPr>
            <a:xfrm>
              <a:off x="4427984" y="6165304"/>
              <a:ext cx="540368" cy="307196"/>
              <a:chOff x="3365984" y="3160132"/>
              <a:chExt cx="540368" cy="307196"/>
            </a:xfrm>
          </p:grpSpPr>
          <p:sp>
            <p:nvSpPr>
              <p:cNvPr id="64" name="Textfeld 63"/>
              <p:cNvSpPr txBox="1"/>
              <p:nvPr/>
            </p:nvSpPr>
            <p:spPr>
              <a:xfrm>
                <a:off x="3365984" y="320571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3510000" y="316013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66" name="Textfeld 65"/>
            <p:cNvSpPr txBox="1"/>
            <p:nvPr/>
          </p:nvSpPr>
          <p:spPr>
            <a:xfrm>
              <a:off x="5119200" y="6191726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67" name="Gruppieren 66"/>
            <p:cNvGrpSpPr/>
            <p:nvPr/>
          </p:nvGrpSpPr>
          <p:grpSpPr>
            <a:xfrm>
              <a:off x="6084168" y="5615662"/>
              <a:ext cx="504056" cy="883260"/>
              <a:chOff x="3337488" y="2656076"/>
              <a:chExt cx="504056" cy="883260"/>
            </a:xfrm>
          </p:grpSpPr>
          <p:sp>
            <p:nvSpPr>
              <p:cNvPr id="68" name="Textfeld 67"/>
              <p:cNvSpPr txBox="1"/>
              <p:nvPr/>
            </p:nvSpPr>
            <p:spPr>
              <a:xfrm>
                <a:off x="3337488" y="327772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3445192" y="265607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70" name="Gruppieren 69"/>
            <p:cNvGrpSpPr/>
            <p:nvPr/>
          </p:nvGrpSpPr>
          <p:grpSpPr>
            <a:xfrm>
              <a:off x="6066000" y="2375302"/>
              <a:ext cx="576233" cy="910308"/>
              <a:chOff x="3439496" y="2682497"/>
              <a:chExt cx="480194" cy="910308"/>
            </a:xfrm>
          </p:grpSpPr>
          <p:sp>
            <p:nvSpPr>
              <p:cNvPr id="71" name="Textfeld 70"/>
              <p:cNvSpPr txBox="1"/>
              <p:nvPr/>
            </p:nvSpPr>
            <p:spPr>
              <a:xfrm>
                <a:off x="3439496" y="3331195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72" name="Textfeld 71"/>
              <p:cNvSpPr txBox="1"/>
              <p:nvPr/>
            </p:nvSpPr>
            <p:spPr>
              <a:xfrm>
                <a:off x="3523338" y="2682497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73" name="Gruppieren 72"/>
            <p:cNvGrpSpPr/>
            <p:nvPr/>
          </p:nvGrpSpPr>
          <p:grpSpPr>
            <a:xfrm>
              <a:off x="6541200" y="2700000"/>
              <a:ext cx="576426" cy="513610"/>
              <a:chOff x="3400496" y="2989694"/>
              <a:chExt cx="480355" cy="513610"/>
            </a:xfrm>
          </p:grpSpPr>
          <p:sp>
            <p:nvSpPr>
              <p:cNvPr id="74" name="Textfeld 73"/>
              <p:cNvSpPr txBox="1"/>
              <p:nvPr/>
            </p:nvSpPr>
            <p:spPr>
              <a:xfrm>
                <a:off x="3400496" y="324169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75" name="Textfeld 74"/>
              <p:cNvSpPr txBox="1"/>
              <p:nvPr/>
            </p:nvSpPr>
            <p:spPr>
              <a:xfrm>
                <a:off x="3484499" y="298969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76" name="Gruppieren 75"/>
            <p:cNvGrpSpPr/>
            <p:nvPr/>
          </p:nvGrpSpPr>
          <p:grpSpPr>
            <a:xfrm>
              <a:off x="6066001" y="1296000"/>
              <a:ext cx="598022" cy="882442"/>
              <a:chOff x="3372261" y="2872100"/>
              <a:chExt cx="498352" cy="882442"/>
            </a:xfrm>
          </p:grpSpPr>
          <p:sp>
            <p:nvSpPr>
              <p:cNvPr id="77" name="Textfeld 76"/>
              <p:cNvSpPr txBox="1"/>
              <p:nvPr/>
            </p:nvSpPr>
            <p:spPr>
              <a:xfrm>
                <a:off x="3372261" y="349293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78" name="Textfeld 77"/>
              <p:cNvSpPr txBox="1"/>
              <p:nvPr/>
            </p:nvSpPr>
            <p:spPr>
              <a:xfrm>
                <a:off x="3474261" y="28721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79" name="Gruppieren 78"/>
            <p:cNvGrpSpPr/>
            <p:nvPr/>
          </p:nvGrpSpPr>
          <p:grpSpPr>
            <a:xfrm>
              <a:off x="6570000" y="1799238"/>
              <a:ext cx="590820" cy="370372"/>
              <a:chOff x="3430608" y="3160132"/>
              <a:chExt cx="492348" cy="370372"/>
            </a:xfrm>
          </p:grpSpPr>
          <p:sp>
            <p:nvSpPr>
              <p:cNvPr id="80" name="Textfeld 79"/>
              <p:cNvSpPr txBox="1"/>
              <p:nvPr/>
            </p:nvSpPr>
            <p:spPr>
              <a:xfrm>
                <a:off x="3430608" y="3268894"/>
                <a:ext cx="39635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81" name="Textfeld 80"/>
              <p:cNvSpPr txBox="1"/>
              <p:nvPr/>
            </p:nvSpPr>
            <p:spPr>
              <a:xfrm>
                <a:off x="3526605" y="3160132"/>
                <a:ext cx="39635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82" name="Gruppieren 81"/>
            <p:cNvGrpSpPr/>
            <p:nvPr/>
          </p:nvGrpSpPr>
          <p:grpSpPr>
            <a:xfrm>
              <a:off x="2322000" y="1728000"/>
              <a:ext cx="540352" cy="476864"/>
              <a:chOff x="3384544" y="2781698"/>
              <a:chExt cx="540352" cy="476864"/>
            </a:xfrm>
          </p:grpSpPr>
          <p:sp>
            <p:nvSpPr>
              <p:cNvPr id="83" name="Textfeld 82"/>
              <p:cNvSpPr txBox="1"/>
              <p:nvPr/>
            </p:nvSpPr>
            <p:spPr>
              <a:xfrm>
                <a:off x="3384544" y="299695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84" name="Textfeld 83"/>
              <p:cNvSpPr txBox="1"/>
              <p:nvPr/>
            </p:nvSpPr>
            <p:spPr>
              <a:xfrm>
                <a:off x="3528544" y="278169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85" name="Textfeld 84"/>
            <p:cNvSpPr txBox="1"/>
            <p:nvPr/>
          </p:nvSpPr>
          <p:spPr>
            <a:xfrm>
              <a:off x="3167536" y="1908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86" name="Gruppieren 85"/>
            <p:cNvGrpSpPr/>
            <p:nvPr/>
          </p:nvGrpSpPr>
          <p:grpSpPr>
            <a:xfrm>
              <a:off x="3715200" y="1476000"/>
              <a:ext cx="540352" cy="693610"/>
              <a:chOff x="3409592" y="2817730"/>
              <a:chExt cx="540352" cy="693610"/>
            </a:xfrm>
          </p:grpSpPr>
          <p:sp>
            <p:nvSpPr>
              <p:cNvPr id="87" name="Textfeld 86"/>
              <p:cNvSpPr txBox="1"/>
              <p:nvPr/>
            </p:nvSpPr>
            <p:spPr>
              <a:xfrm>
                <a:off x="3409592" y="324973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88" name="Textfeld 87"/>
              <p:cNvSpPr txBox="1"/>
              <p:nvPr/>
            </p:nvSpPr>
            <p:spPr>
              <a:xfrm>
                <a:off x="3553592" y="281773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89" name="Gruppieren 88"/>
            <p:cNvGrpSpPr/>
            <p:nvPr/>
          </p:nvGrpSpPr>
          <p:grpSpPr>
            <a:xfrm>
              <a:off x="4410000" y="1908000"/>
              <a:ext cx="551136" cy="279610"/>
              <a:chOff x="3384312" y="2935283"/>
              <a:chExt cx="551136" cy="279610"/>
            </a:xfrm>
          </p:grpSpPr>
          <p:sp>
            <p:nvSpPr>
              <p:cNvPr id="90" name="Textfeld 89"/>
              <p:cNvSpPr txBox="1"/>
              <p:nvPr/>
            </p:nvSpPr>
            <p:spPr>
              <a:xfrm>
                <a:off x="3384312" y="2953283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91" name="Textfeld 90"/>
              <p:cNvSpPr txBox="1"/>
              <p:nvPr/>
            </p:nvSpPr>
            <p:spPr>
              <a:xfrm>
                <a:off x="3539096" y="2935283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92" name="Textfeld 91"/>
            <p:cNvSpPr txBox="1"/>
            <p:nvPr/>
          </p:nvSpPr>
          <p:spPr>
            <a:xfrm>
              <a:off x="5111752" y="1944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93" name="Gruppieren 92"/>
            <p:cNvGrpSpPr/>
            <p:nvPr/>
          </p:nvGrpSpPr>
          <p:grpSpPr>
            <a:xfrm>
              <a:off x="6074479" y="575102"/>
              <a:ext cx="585753" cy="549642"/>
              <a:chOff x="3409496" y="3140968"/>
              <a:chExt cx="488128" cy="549642"/>
            </a:xfrm>
          </p:grpSpPr>
          <p:sp>
            <p:nvSpPr>
              <p:cNvPr id="94" name="Textfeld 93"/>
              <p:cNvSpPr txBox="1"/>
              <p:nvPr/>
            </p:nvSpPr>
            <p:spPr>
              <a:xfrm>
                <a:off x="3409496" y="342900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95" name="Textfeld 94"/>
              <p:cNvSpPr txBox="1"/>
              <p:nvPr/>
            </p:nvSpPr>
            <p:spPr>
              <a:xfrm>
                <a:off x="3501272" y="314096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96" name="Gruppieren 95"/>
            <p:cNvGrpSpPr/>
            <p:nvPr/>
          </p:nvGrpSpPr>
          <p:grpSpPr>
            <a:xfrm>
              <a:off x="6578535" y="287070"/>
              <a:ext cx="585753" cy="811252"/>
              <a:chOff x="3409496" y="2826514"/>
              <a:chExt cx="488128" cy="811252"/>
            </a:xfrm>
          </p:grpSpPr>
          <p:sp>
            <p:nvSpPr>
              <p:cNvPr id="97" name="Textfeld 96"/>
              <p:cNvSpPr txBox="1"/>
              <p:nvPr/>
            </p:nvSpPr>
            <p:spPr>
              <a:xfrm>
                <a:off x="3409496" y="337615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3501272" y="282651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99" name="Gruppieren 98"/>
            <p:cNvGrpSpPr/>
            <p:nvPr/>
          </p:nvGrpSpPr>
          <p:grpSpPr>
            <a:xfrm>
              <a:off x="6066001" y="3528000"/>
              <a:ext cx="583624" cy="837104"/>
              <a:chOff x="3409496" y="2755076"/>
              <a:chExt cx="486352" cy="837104"/>
            </a:xfrm>
          </p:grpSpPr>
          <p:sp>
            <p:nvSpPr>
              <p:cNvPr id="100" name="Textfeld 99"/>
              <p:cNvSpPr txBox="1"/>
              <p:nvPr/>
            </p:nvSpPr>
            <p:spPr>
              <a:xfrm>
                <a:off x="3409496" y="333057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01" name="Textfeld 100"/>
              <p:cNvSpPr txBox="1"/>
              <p:nvPr/>
            </p:nvSpPr>
            <p:spPr>
              <a:xfrm>
                <a:off x="3499496" y="2755076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02" name="Gruppieren 101"/>
            <p:cNvGrpSpPr/>
            <p:nvPr/>
          </p:nvGrpSpPr>
          <p:grpSpPr>
            <a:xfrm>
              <a:off x="6570000" y="4031486"/>
              <a:ext cx="576060" cy="333618"/>
              <a:chOff x="3409496" y="3232140"/>
              <a:chExt cx="480050" cy="333618"/>
            </a:xfrm>
          </p:grpSpPr>
          <p:sp>
            <p:nvSpPr>
              <p:cNvPr id="103" name="Textfeld 102"/>
              <p:cNvSpPr txBox="1"/>
              <p:nvPr/>
            </p:nvSpPr>
            <p:spPr>
              <a:xfrm>
                <a:off x="3409496" y="3304148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04" name="Textfeld 103"/>
              <p:cNvSpPr txBox="1"/>
              <p:nvPr/>
            </p:nvSpPr>
            <p:spPr>
              <a:xfrm>
                <a:off x="3493194" y="323214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105" name="Textfeld 104"/>
            <p:cNvSpPr txBox="1"/>
            <p:nvPr/>
          </p:nvSpPr>
          <p:spPr>
            <a:xfrm>
              <a:off x="6138000" y="4581129"/>
              <a:ext cx="4756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06" name="Textfeld 105"/>
            <p:cNvSpPr txBox="1"/>
            <p:nvPr/>
          </p:nvSpPr>
          <p:spPr>
            <a:xfrm>
              <a:off x="6642000" y="5112000"/>
              <a:ext cx="475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2404800" y="4608000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3131840" y="5183614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09" name="Textfeld 108"/>
            <p:cNvSpPr txBox="1"/>
            <p:nvPr/>
          </p:nvSpPr>
          <p:spPr>
            <a:xfrm>
              <a:off x="4521600" y="5157192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grpSp>
          <p:nvGrpSpPr>
            <p:cNvPr id="110" name="Gruppieren 109"/>
            <p:cNvGrpSpPr/>
            <p:nvPr/>
          </p:nvGrpSpPr>
          <p:grpSpPr>
            <a:xfrm>
              <a:off x="3718800" y="3636000"/>
              <a:ext cx="547952" cy="702682"/>
              <a:chOff x="3358784" y="2817490"/>
              <a:chExt cx="547952" cy="702682"/>
            </a:xfrm>
          </p:grpSpPr>
          <p:sp>
            <p:nvSpPr>
              <p:cNvPr id="111" name="Textfeld 110"/>
              <p:cNvSpPr txBox="1"/>
              <p:nvPr/>
            </p:nvSpPr>
            <p:spPr>
              <a:xfrm>
                <a:off x="3358784" y="3258562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12" name="Textfeld 111"/>
              <p:cNvSpPr txBox="1"/>
              <p:nvPr/>
            </p:nvSpPr>
            <p:spPr>
              <a:xfrm>
                <a:off x="3510384" y="2817490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grpSp>
          <p:nvGrpSpPr>
            <p:cNvPr id="113" name="Gruppieren 112"/>
            <p:cNvGrpSpPr/>
            <p:nvPr/>
          </p:nvGrpSpPr>
          <p:grpSpPr>
            <a:xfrm>
              <a:off x="6588224" y="6119718"/>
              <a:ext cx="594198" cy="379203"/>
              <a:chOff x="3409496" y="3232141"/>
              <a:chExt cx="495165" cy="379203"/>
            </a:xfrm>
          </p:grpSpPr>
          <p:sp>
            <p:nvSpPr>
              <p:cNvPr id="114" name="Textfeld 113"/>
              <p:cNvSpPr txBox="1"/>
              <p:nvPr/>
            </p:nvSpPr>
            <p:spPr>
              <a:xfrm>
                <a:off x="3409496" y="3349734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  <p:sp>
            <p:nvSpPr>
              <p:cNvPr id="115" name="Textfeld 114"/>
              <p:cNvSpPr txBox="1"/>
              <p:nvPr/>
            </p:nvSpPr>
            <p:spPr>
              <a:xfrm>
                <a:off x="3508309" y="3232141"/>
                <a:ext cx="396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/>
                  <a:t>*</a:t>
                </a:r>
                <a:endParaRPr lang="de-DE" sz="1100" dirty="0"/>
              </a:p>
            </p:txBody>
          </p:sp>
        </p:grpSp>
        <p:sp>
          <p:nvSpPr>
            <p:cNvPr id="116" name="Textfeld 115"/>
            <p:cNvSpPr txBox="1"/>
            <p:nvPr/>
          </p:nvSpPr>
          <p:spPr>
            <a:xfrm rot="16200000">
              <a:off x="706758" y="345868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feld 116"/>
            <p:cNvSpPr txBox="1"/>
            <p:nvPr/>
          </p:nvSpPr>
          <p:spPr>
            <a:xfrm rot="16200000">
              <a:off x="706758" y="2506108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3</a:t>
              </a:r>
            </a:p>
          </p:txBody>
        </p:sp>
        <p:sp>
          <p:nvSpPr>
            <p:cNvPr id="118" name="Textfeld 117"/>
            <p:cNvSpPr txBox="1"/>
            <p:nvPr/>
          </p:nvSpPr>
          <p:spPr>
            <a:xfrm rot="16200000">
              <a:off x="706758" y="3586228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4</a:t>
              </a:r>
            </a:p>
          </p:txBody>
        </p:sp>
        <p:sp>
          <p:nvSpPr>
            <p:cNvPr id="119" name="Textfeld 118"/>
            <p:cNvSpPr txBox="1"/>
            <p:nvPr/>
          </p:nvSpPr>
          <p:spPr>
            <a:xfrm rot="16200000">
              <a:off x="706758" y="4666348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IDUC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feld 119"/>
            <p:cNvSpPr txBox="1"/>
            <p:nvPr/>
          </p:nvSpPr>
          <p:spPr>
            <a:xfrm rot="16200000">
              <a:off x="706758" y="5674460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FDUC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feld 120"/>
            <p:cNvSpPr txBox="1"/>
            <p:nvPr/>
          </p:nvSpPr>
          <p:spPr>
            <a:xfrm rot="16200000">
              <a:off x="706758" y="1425988"/>
              <a:ext cx="12961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2</a:t>
              </a:r>
            </a:p>
          </p:txBody>
        </p:sp>
        <p:sp>
          <p:nvSpPr>
            <p:cNvPr id="122" name="Rechteck 121"/>
            <p:cNvSpPr/>
            <p:nvPr/>
          </p:nvSpPr>
          <p:spPr>
            <a:xfrm>
              <a:off x="1170552" y="163772"/>
              <a:ext cx="319500" cy="1104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3" name="Rechteck 122"/>
            <p:cNvSpPr/>
            <p:nvPr/>
          </p:nvSpPr>
          <p:spPr>
            <a:xfrm>
              <a:off x="1170552" y="1268761"/>
              <a:ext cx="319500" cy="10801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4" name="Rechteck 123"/>
            <p:cNvSpPr/>
            <p:nvPr/>
          </p:nvSpPr>
          <p:spPr>
            <a:xfrm>
              <a:off x="1170552" y="2348881"/>
              <a:ext cx="319500" cy="10801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5" name="Rechteck 124"/>
            <p:cNvSpPr/>
            <p:nvPr/>
          </p:nvSpPr>
          <p:spPr>
            <a:xfrm>
              <a:off x="1170552" y="3429001"/>
              <a:ext cx="319500" cy="107457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6" name="Rechteck 125"/>
            <p:cNvSpPr/>
            <p:nvPr/>
          </p:nvSpPr>
          <p:spPr>
            <a:xfrm>
              <a:off x="1170552" y="4503577"/>
              <a:ext cx="319500" cy="107460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7" name="Rechteck 126"/>
            <p:cNvSpPr/>
            <p:nvPr/>
          </p:nvSpPr>
          <p:spPr>
            <a:xfrm>
              <a:off x="1170552" y="5578182"/>
              <a:ext cx="319500" cy="10763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8" name="Rechteck 127"/>
            <p:cNvSpPr/>
            <p:nvPr/>
          </p:nvSpPr>
          <p:spPr>
            <a:xfrm>
              <a:off x="1493176" y="163773"/>
              <a:ext cx="5570670" cy="1104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9" name="Rechteck 128"/>
            <p:cNvSpPr/>
            <p:nvPr/>
          </p:nvSpPr>
          <p:spPr>
            <a:xfrm>
              <a:off x="1493176" y="1268761"/>
              <a:ext cx="5570670" cy="10801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0" name="Rechteck 129"/>
            <p:cNvSpPr/>
            <p:nvPr/>
          </p:nvSpPr>
          <p:spPr>
            <a:xfrm>
              <a:off x="1493176" y="2348881"/>
              <a:ext cx="5570670" cy="10801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1" name="Rechteck 130"/>
            <p:cNvSpPr/>
            <p:nvPr/>
          </p:nvSpPr>
          <p:spPr>
            <a:xfrm>
              <a:off x="1493176" y="3429001"/>
              <a:ext cx="5570670" cy="107460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2" name="Rechteck 131"/>
            <p:cNvSpPr/>
            <p:nvPr/>
          </p:nvSpPr>
          <p:spPr>
            <a:xfrm>
              <a:off x="1493176" y="4503577"/>
              <a:ext cx="5570670" cy="107460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3" name="Rechteck 132"/>
            <p:cNvSpPr/>
            <p:nvPr/>
          </p:nvSpPr>
          <p:spPr>
            <a:xfrm>
              <a:off x="1493176" y="5579977"/>
              <a:ext cx="5570670" cy="107460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4" name="Textfeld 133"/>
            <p:cNvSpPr txBox="1"/>
            <p:nvPr/>
          </p:nvSpPr>
          <p:spPr>
            <a:xfrm>
              <a:off x="3726000" y="764704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35" name="Textfeld 134"/>
            <p:cNvSpPr txBox="1"/>
            <p:nvPr/>
          </p:nvSpPr>
          <p:spPr>
            <a:xfrm>
              <a:off x="3707904" y="6237312"/>
              <a:ext cx="396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/>
                <a:t>*</a:t>
              </a:r>
              <a:endParaRPr lang="de-DE" sz="1100" dirty="0"/>
            </a:p>
          </p:txBody>
        </p:sp>
        <p:sp>
          <p:nvSpPr>
            <p:cNvPr id="136" name="Textfeld 135"/>
            <p:cNvSpPr txBox="1"/>
            <p:nvPr/>
          </p:nvSpPr>
          <p:spPr>
            <a:xfrm>
              <a:off x="5746976" y="6400666"/>
              <a:ext cx="1705344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de-DE" sz="9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C      ADSC      MES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Rechteck 136"/>
            <p:cNvSpPr/>
            <p:nvPr/>
          </p:nvSpPr>
          <p:spPr>
            <a:xfrm>
              <a:off x="6174400" y="6726763"/>
              <a:ext cx="84756" cy="79200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8" name="Rechteck 137"/>
            <p:cNvSpPr/>
            <p:nvPr/>
          </p:nvSpPr>
          <p:spPr>
            <a:xfrm>
              <a:off x="5724128" y="6726763"/>
              <a:ext cx="84756" cy="792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9" name="Rechteck 138"/>
            <p:cNvSpPr/>
            <p:nvPr/>
          </p:nvSpPr>
          <p:spPr>
            <a:xfrm>
              <a:off x="6660232" y="6726763"/>
              <a:ext cx="84756" cy="79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277198941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Bildschirmpräsentation (4:3)</PresentationFormat>
  <Paragraphs>8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igand, Annika</dc:creator>
  <cp:lastModifiedBy>Weigand, Annika</cp:lastModifiedBy>
  <cp:revision>273</cp:revision>
  <cp:lastPrinted>2015-09-30T10:22:51Z</cp:lastPrinted>
  <dcterms:created xsi:type="dcterms:W3CDTF">2014-07-18T07:51:48Z</dcterms:created>
  <dcterms:modified xsi:type="dcterms:W3CDTF">2016-01-22T15:49:43Z</dcterms:modified>
</cp:coreProperties>
</file>